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1"/>
    <p:restoredTop sz="94679"/>
  </p:normalViewPr>
  <p:slideViewPr>
    <p:cSldViewPr snapToGrid="0" snapToObjects="1" showGuides="1">
      <p:cViewPr>
        <p:scale>
          <a:sx n="97" d="100"/>
          <a:sy n="97" d="100"/>
        </p:scale>
        <p:origin x="568" y="14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E7F5FD-9F50-4443-8C66-4DC262ADA8E9}" type="datetimeFigureOut">
              <a:rPr lang="en-US" smtClean="0"/>
              <a:t>2/18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3F94B5-6E24-3B4B-937D-6D66F9A1162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477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3F94B5-6E24-3B4B-937D-6D66F9A1162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5387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6679D-2426-1C4D-A5C3-31B25BC8988D}" type="datetimeFigureOut">
              <a:rPr lang="en-US" smtClean="0"/>
              <a:t>2/18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0E1943-6A73-374F-8C56-9358031502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141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71489" y="6362337"/>
            <a:ext cx="6082748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Cross-Resistance Table upper triangle shows proportion of samples with a known phenotype for both vertical and horizontal phenotype, that test positive for vertical phenotype. Diagonal (in bold) shows number of samples with a known phenotype for each phenotype</a:t>
            </a:r>
            <a:r>
              <a:rPr lang="en-US" sz="1400" dirty="0"/>
              <a:t>.</a:t>
            </a:r>
            <a:r>
              <a:rPr lang="en-US" sz="1400" dirty="0" smtClean="0"/>
              <a:t> </a:t>
            </a:r>
            <a:r>
              <a:rPr lang="en-US" sz="1400" dirty="0"/>
              <a:t>L</a:t>
            </a:r>
            <a:r>
              <a:rPr lang="en-US" sz="1400" dirty="0" smtClean="0"/>
              <a:t>ower triangle shows number of samples with a known phenotype for both horizontal and vertical phenotype.</a:t>
            </a:r>
            <a:endParaRPr lang="en-US" sz="14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69710484"/>
              </p:ext>
            </p:extLst>
          </p:nvPr>
        </p:nvGraphicFramePr>
        <p:xfrm>
          <a:off x="471489" y="2569058"/>
          <a:ext cx="5915022" cy="303844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09046"/>
                <a:gridCol w="425498"/>
                <a:gridCol w="425498"/>
                <a:gridCol w="425498"/>
                <a:gridCol w="425498"/>
                <a:gridCol w="425498"/>
                <a:gridCol w="425498"/>
                <a:gridCol w="425498"/>
                <a:gridCol w="425498"/>
                <a:gridCol w="425498"/>
                <a:gridCol w="425498"/>
                <a:gridCol w="425498"/>
                <a:gridCol w="425498"/>
              </a:tblGrid>
              <a:tr h="104336">
                <a:tc>
                  <a:txBody>
                    <a:bodyPr/>
                    <a:lstStyle/>
                    <a:p>
                      <a:pPr algn="l" fontAlgn="b"/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M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INH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CI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MOX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OFL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AMK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CA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KAN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STRE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AMB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PZA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ETH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RM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4056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INH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93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3967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3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CI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8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7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184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</a:rPr>
                        <a:t>NA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4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MOX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4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5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459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OFL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2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1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534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AMK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8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7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5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5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692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CA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1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0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5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2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0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819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KAN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1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1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2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0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3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9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617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STREP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4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6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4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4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8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8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0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161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2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EMB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03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05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8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5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56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70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61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5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3057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PZA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42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42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4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3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8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9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1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6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64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4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2435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3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1043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>
                          <a:effectLst/>
                        </a:rPr>
                        <a:t>ETH</a:t>
                      </a:r>
                      <a:endParaRPr lang="en-US" sz="1200" b="1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43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2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41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38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1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257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32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9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u="none" strike="noStrike" dirty="0">
                          <a:effectLst/>
                        </a:rPr>
                        <a:t>448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  <a:tr h="313007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effectLst/>
                        </a:rPr>
                        <a:t>Proportion of samples </a:t>
                      </a:r>
                      <a:r>
                        <a:rPr lang="en-US" sz="1200" b="1" u="none" strike="noStrike" dirty="0" err="1">
                          <a:effectLst/>
                        </a:rPr>
                        <a:t>phenotyped</a:t>
                      </a:r>
                      <a:endParaRPr lang="en-US" sz="1200" b="1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9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9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0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0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2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6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14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4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69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0.55</a:t>
                      </a:r>
                      <a:endParaRPr lang="en-US" sz="1200" b="0" i="0" u="none" strike="noStrike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 dirty="0">
                          <a:effectLst/>
                        </a:rPr>
                        <a:t>0.10</a:t>
                      </a:r>
                      <a:endParaRPr lang="en-US" sz="1200" b="0" i="0" u="none" strike="noStrike" dirty="0">
                        <a:effectLst/>
                        <a:latin typeface="Arial" charset="0"/>
                      </a:endParaRPr>
                    </a:p>
                  </a:txBody>
                  <a:tcPr marL="8026" marR="8026" marT="8026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122796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70</TotalTime>
  <Words>245</Words>
  <Application>Microsoft Macintosh PowerPoint</Application>
  <PresentationFormat>A4 Paper (210x297 mm)</PresentationFormat>
  <Paragraphs>18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ppong, Yaa</dc:creator>
  <cp:lastModifiedBy>Oppong, Yaa</cp:lastModifiedBy>
  <cp:revision>8</cp:revision>
  <dcterms:created xsi:type="dcterms:W3CDTF">2018-02-01T17:47:13Z</dcterms:created>
  <dcterms:modified xsi:type="dcterms:W3CDTF">2019-02-18T13:42:28Z</dcterms:modified>
</cp:coreProperties>
</file>